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B6D19-3C19-4B99-943B-F698C24556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A68FD-FCC6-4D3F-A95F-EC2A6B6F2E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A4F285-B899-4103-ABCA-603D8DC077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B7E78-72BF-4EE8-B9F8-FDC462D471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42615-5E4B-4384-B7BD-7773486B84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FD5A2-B325-4255-BDD6-512E8CF695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D868C-B5F7-4B4E-90BE-7D6F7B2318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AD8F9-B6B2-4BAF-9865-9C374E5FEE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63560A-B21B-4015-B114-88220D3DEC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81241-AAB0-40D0-BC3D-30AC0D0E3C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28842-2492-4DB1-9507-2C99A6E38F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7553D-CF53-49E2-BF1F-D808A54E47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7F285E-F767-41A7-A630-6CBE0AB39B5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argeted phenotypic culturing facilitates bacterial discovery from healthy human faecal microbiot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3025800" y="1181160"/>
            <a:ext cx="3092400" cy="45259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D:\PPT_Out\nature-logo.jpg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 P Brown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et al. Natur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–4 (2016) doi:10.1038/nature1764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29T09:21:34Z</dcterms:created>
  <dc:creator>ravikumar.n</dc:creator>
  <dc:description/>
  <dc:language>en-US</dc:language>
  <cp:lastModifiedBy>R.Vijitha</cp:lastModifiedBy>
  <dcterms:modified xsi:type="dcterms:W3CDTF">2016-04-29T09:24:17Z</dcterms:modified>
  <cp:revision>2</cp:revision>
  <dc:subject/>
  <dc:title>Targeted phenotypic culturing facilitates bacterial discovery from healthy human faecal microbiota</dc:title>
</cp:coreProperties>
</file>